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1791"/>
  </p:normalViewPr>
  <p:slideViewPr>
    <p:cSldViewPr snapToGrid="0">
      <p:cViewPr>
        <p:scale>
          <a:sx n="120" d="100"/>
          <a:sy n="120" d="100"/>
        </p:scale>
        <p:origin x="2240" y="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805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15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43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868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76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876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513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92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269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313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802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D8CD0-2D1A-42D8-8E01-291304942633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41F7B-ABBD-4750-83FB-5E35AAE1D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079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5089CFF-F086-44D2-BEEF-F2C87AA767A6}"/>
              </a:ext>
            </a:extLst>
          </p:cNvPr>
          <p:cNvSpPr txBox="1"/>
          <p:nvPr/>
        </p:nvSpPr>
        <p:spPr>
          <a:xfrm>
            <a:off x="850604" y="5624623"/>
            <a:ext cx="74427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 Fig. Median-joining network for PpSP30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61C85C1-2B3C-0541-9C3C-2CA3C5F444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699" y="88309"/>
            <a:ext cx="5492602" cy="54495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1327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4</TotalTime>
  <Words>51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5</cp:revision>
  <dcterms:created xsi:type="dcterms:W3CDTF">2019-01-18T01:47:40Z</dcterms:created>
  <dcterms:modified xsi:type="dcterms:W3CDTF">2020-06-22T01:35:10Z</dcterms:modified>
</cp:coreProperties>
</file>